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969" r:id="rId2"/>
  </p:sldIdLst>
  <p:sldSz cx="6858000" cy="9906000" type="A4"/>
  <p:notesSz cx="6858000" cy="9144000"/>
  <p:defaultTextStyle>
    <a:defPPr>
      <a:defRPr lang="en-US"/>
    </a:defPPr>
    <a:lvl1pPr marL="0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68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38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506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75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843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013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181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351" algn="l" defTabSz="457168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1" userDrawn="1">
          <p15:clr>
            <a:srgbClr val="A4A3A4"/>
          </p15:clr>
        </p15:guide>
        <p15:guide id="2" pos="216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FF00"/>
    <a:srgbClr val="FCEEF7"/>
    <a:srgbClr val="FBE9FB"/>
    <a:srgbClr val="F8DCF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3784" autoAdjust="0"/>
  </p:normalViewPr>
  <p:slideViewPr>
    <p:cSldViewPr snapToGrid="0">
      <p:cViewPr>
        <p:scale>
          <a:sx n="150" d="100"/>
          <a:sy n="150" d="100"/>
        </p:scale>
        <p:origin x="1464" y="-1476"/>
      </p:cViewPr>
      <p:guideLst>
        <p:guide orient="horz" pos="3121"/>
        <p:guide pos="2161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92F547-D850-4018-AA1D-F8DCC99CCBEA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6AFB34-6CFC-498A-BE1B-552DE47A8E0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8792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68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38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06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675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843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013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181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351" algn="l" defTabSz="914338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1621194"/>
            <a:ext cx="5829300" cy="344875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1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2940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85031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527406"/>
            <a:ext cx="1478755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6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9393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14222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7"/>
            <a:ext cx="5915025" cy="412061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5"/>
            <a:ext cx="5915025" cy="216693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92639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9" y="2637014"/>
            <a:ext cx="2914651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5" y="2637014"/>
            <a:ext cx="2914651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226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8"/>
            <a:ext cx="5915025" cy="191470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3" y="2428350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3" y="3618444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50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862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6026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7903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660399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5"/>
            <a:ext cx="3471863" cy="703968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2" y="2971803"/>
            <a:ext cx="2211884" cy="550562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80348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660399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5"/>
            <a:ext cx="3471863" cy="703968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2" y="2971803"/>
            <a:ext cx="2211884" cy="550562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6665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8"/>
            <a:ext cx="5915025" cy="19147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9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A04C04-CBC2-43F7-8F0F-8963EB925069}" type="datetimeFigureOut">
              <a:rPr kumimoji="1" lang="ja-JP" altLang="en-US" smtClean="0"/>
              <a:t>2025/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401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E1205A-4709-4134-8AC4-82A5E80AAA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91963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694208A-AA16-F56E-47E6-1DDA673D9D33}"/>
              </a:ext>
            </a:extLst>
          </p:cNvPr>
          <p:cNvSpPr txBox="1"/>
          <p:nvPr/>
        </p:nvSpPr>
        <p:spPr>
          <a:xfrm>
            <a:off x="18338" y="427878"/>
            <a:ext cx="68507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in endoscopic biopsy 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6F41D6F-9EF5-7B3E-8F67-DC862CFBD02C}"/>
              </a:ext>
            </a:extLst>
          </p:cNvPr>
          <p:cNvSpPr txBox="1"/>
          <p:nvPr/>
        </p:nvSpPr>
        <p:spPr>
          <a:xfrm>
            <a:off x="2" y="20965"/>
            <a:ext cx="68409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. Relation between expression of CD3,CD8,Foxp3 and CCR8 lymphocytes and </a:t>
            </a:r>
            <a:r>
              <a:rPr lang="en-US" altLang="ja-JP" sz="1200" b="1" u="sng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gression-free survival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nivolumab</a:t>
            </a:r>
            <a:endParaRPr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3" name="図 62">
            <a:extLst>
              <a:ext uri="{FF2B5EF4-FFF2-40B4-BE49-F238E27FC236}">
                <a16:creationId xmlns:a16="http://schemas.microsoft.com/office/drawing/2014/main" id="{06C35382-D10D-F154-0CB0-B8C443C990CD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857597" y="835154"/>
            <a:ext cx="2866003" cy="1776977"/>
          </a:xfrm>
          <a:prstGeom prst="rect">
            <a:avLst/>
          </a:prstGeom>
        </p:spPr>
      </p:pic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BADD7F82-8538-BCA4-96C6-D1F81A128C65}"/>
              </a:ext>
            </a:extLst>
          </p:cNvPr>
          <p:cNvSpPr txBox="1"/>
          <p:nvPr/>
        </p:nvSpPr>
        <p:spPr>
          <a:xfrm>
            <a:off x="4417834" y="2304537"/>
            <a:ext cx="2076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months)</a:t>
            </a: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F3DD04B8-9597-BD19-73C5-F1FFE910290D}"/>
              </a:ext>
            </a:extLst>
          </p:cNvPr>
          <p:cNvSpPr txBox="1"/>
          <p:nvPr/>
        </p:nvSpPr>
        <p:spPr>
          <a:xfrm rot="16200000">
            <a:off x="2914448" y="1455630"/>
            <a:ext cx="2120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ression-free survival rate</a:t>
            </a: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752D400F-CFA5-6742-3A37-DC62828F6372}"/>
              </a:ext>
            </a:extLst>
          </p:cNvPr>
          <p:cNvSpPr txBox="1"/>
          <p:nvPr/>
        </p:nvSpPr>
        <p:spPr>
          <a:xfrm>
            <a:off x="4269634" y="1919474"/>
            <a:ext cx="8662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14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7F6FB2D6-C07D-84C5-106B-89387C9E5E9B}"/>
              </a:ext>
            </a:extLst>
          </p:cNvPr>
          <p:cNvSpPr txBox="1"/>
          <p:nvPr/>
        </p:nvSpPr>
        <p:spPr>
          <a:xfrm>
            <a:off x="5108424" y="990308"/>
            <a:ext cx="15514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200" b="1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8 high (n=61)</a:t>
            </a:r>
          </a:p>
          <a:p>
            <a:r>
              <a:rPr kumimoji="1" lang="ja-JP" altLang="en-US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CR8 low (n=60)</a:t>
            </a:r>
          </a:p>
        </p:txBody>
      </p:sp>
      <p:pic>
        <p:nvPicPr>
          <p:cNvPr id="69" name="図 68">
            <a:extLst>
              <a:ext uri="{FF2B5EF4-FFF2-40B4-BE49-F238E27FC236}">
                <a16:creationId xmlns:a16="http://schemas.microsoft.com/office/drawing/2014/main" id="{3B190E57-D08A-126E-14C6-EF1491653B65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857597" y="4717944"/>
            <a:ext cx="2886977" cy="1776977"/>
          </a:xfrm>
          <a:prstGeom prst="rect">
            <a:avLst/>
          </a:prstGeom>
        </p:spPr>
      </p:pic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4A5B8E3B-1826-A157-FD7A-DD82771BF423}"/>
              </a:ext>
            </a:extLst>
          </p:cNvPr>
          <p:cNvSpPr txBox="1"/>
          <p:nvPr/>
        </p:nvSpPr>
        <p:spPr>
          <a:xfrm>
            <a:off x="4398311" y="6215503"/>
            <a:ext cx="2076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months)</a:t>
            </a: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2B02B250-FD9F-FA3D-949C-25824A105E49}"/>
              </a:ext>
            </a:extLst>
          </p:cNvPr>
          <p:cNvSpPr txBox="1"/>
          <p:nvPr/>
        </p:nvSpPr>
        <p:spPr>
          <a:xfrm rot="16200000">
            <a:off x="2894925" y="5366596"/>
            <a:ext cx="2120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ression-free survival rate</a:t>
            </a: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ADFDA95E-0769-3A76-9C52-FD9DF4797D5D}"/>
              </a:ext>
            </a:extLst>
          </p:cNvPr>
          <p:cNvSpPr txBox="1"/>
          <p:nvPr/>
        </p:nvSpPr>
        <p:spPr>
          <a:xfrm>
            <a:off x="4250111" y="5830440"/>
            <a:ext cx="8662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092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F42CB02D-D237-88FD-A440-0BC8D6BF19C4}"/>
              </a:ext>
            </a:extLst>
          </p:cNvPr>
          <p:cNvSpPr txBox="1"/>
          <p:nvPr/>
        </p:nvSpPr>
        <p:spPr>
          <a:xfrm>
            <a:off x="4849753" y="4873256"/>
            <a:ext cx="19271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200" b="1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/CCR8 high (n=61)</a:t>
            </a:r>
          </a:p>
          <a:p>
            <a:r>
              <a:rPr kumimoji="1" lang="ja-JP" altLang="en-US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/CCR8 low (n=60)</a:t>
            </a:r>
          </a:p>
        </p:txBody>
      </p:sp>
      <p:pic>
        <p:nvPicPr>
          <p:cNvPr id="75" name="図 74">
            <a:extLst>
              <a:ext uri="{FF2B5EF4-FFF2-40B4-BE49-F238E27FC236}">
                <a16:creationId xmlns:a16="http://schemas.microsoft.com/office/drawing/2014/main" id="{4F7A5498-8676-CD8B-B341-B576F97CE79A}"/>
              </a:ext>
            </a:extLst>
          </p:cNvPr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2109" y="4717944"/>
            <a:ext cx="2852024" cy="1776977"/>
          </a:xfrm>
          <a:prstGeom prst="rect">
            <a:avLst/>
          </a:prstGeom>
        </p:spPr>
      </p:pic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99C0D396-5295-B521-CD3E-985AF903659A}"/>
              </a:ext>
            </a:extLst>
          </p:cNvPr>
          <p:cNvSpPr txBox="1"/>
          <p:nvPr/>
        </p:nvSpPr>
        <p:spPr>
          <a:xfrm>
            <a:off x="744197" y="6175586"/>
            <a:ext cx="2076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months)</a:t>
            </a: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3BD31C25-6B49-6F23-67BC-BE10256954D4}"/>
              </a:ext>
            </a:extLst>
          </p:cNvPr>
          <p:cNvSpPr txBox="1"/>
          <p:nvPr/>
        </p:nvSpPr>
        <p:spPr>
          <a:xfrm rot="16200000">
            <a:off x="-759189" y="5366596"/>
            <a:ext cx="2120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ression-free survival rate</a:t>
            </a: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FD211369-53E2-0EFF-C553-39B0AA7BF1A9}"/>
              </a:ext>
            </a:extLst>
          </p:cNvPr>
          <p:cNvSpPr txBox="1"/>
          <p:nvPr/>
        </p:nvSpPr>
        <p:spPr>
          <a:xfrm>
            <a:off x="595997" y="5830440"/>
            <a:ext cx="8662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21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5C61514A-91D6-5C8D-70A6-3443B7887E38}"/>
              </a:ext>
            </a:extLst>
          </p:cNvPr>
          <p:cNvSpPr txBox="1"/>
          <p:nvPr/>
        </p:nvSpPr>
        <p:spPr>
          <a:xfrm>
            <a:off x="1434788" y="4873256"/>
            <a:ext cx="153128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200" b="1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p3 high (n=61)</a:t>
            </a:r>
          </a:p>
          <a:p>
            <a:r>
              <a:rPr kumimoji="1" lang="ja-JP" altLang="en-US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p3 low (n=60)</a:t>
            </a:r>
          </a:p>
        </p:txBody>
      </p:sp>
      <p:pic>
        <p:nvPicPr>
          <p:cNvPr id="81" name="図 80">
            <a:extLst>
              <a:ext uri="{FF2B5EF4-FFF2-40B4-BE49-F238E27FC236}">
                <a16:creationId xmlns:a16="http://schemas.microsoft.com/office/drawing/2014/main" id="{478EF171-6BAD-0868-86E3-C8FC1219E1E7}"/>
              </a:ext>
            </a:extLst>
          </p:cNvPr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837994" y="2845268"/>
            <a:ext cx="2879983" cy="1776977"/>
          </a:xfrm>
          <a:prstGeom prst="rect">
            <a:avLst/>
          </a:prstGeom>
        </p:spPr>
      </p:pic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37215E45-EA57-A6F2-5FA2-AC55C0F3BA6A}"/>
              </a:ext>
            </a:extLst>
          </p:cNvPr>
          <p:cNvSpPr txBox="1"/>
          <p:nvPr/>
        </p:nvSpPr>
        <p:spPr>
          <a:xfrm>
            <a:off x="4396800" y="4346386"/>
            <a:ext cx="2076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months)</a:t>
            </a: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3100A4EE-0AE0-151E-B15A-6DA861028E70}"/>
              </a:ext>
            </a:extLst>
          </p:cNvPr>
          <p:cNvSpPr txBox="1"/>
          <p:nvPr/>
        </p:nvSpPr>
        <p:spPr>
          <a:xfrm rot="16200000">
            <a:off x="2893414" y="3497479"/>
            <a:ext cx="2120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ression-free survival rate</a:t>
            </a: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1D8813DD-1353-B705-2DF8-8A6C5C47ECB4}"/>
              </a:ext>
            </a:extLst>
          </p:cNvPr>
          <p:cNvSpPr txBox="1"/>
          <p:nvPr/>
        </p:nvSpPr>
        <p:spPr>
          <a:xfrm>
            <a:off x="4248600" y="3961323"/>
            <a:ext cx="8662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337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A906C6CF-6DF3-DBF8-B25B-EA13A359F1A4}"/>
              </a:ext>
            </a:extLst>
          </p:cNvPr>
          <p:cNvSpPr txBox="1"/>
          <p:nvPr/>
        </p:nvSpPr>
        <p:spPr>
          <a:xfrm>
            <a:off x="4848242" y="3003424"/>
            <a:ext cx="19370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200" b="1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/Foxp3 high (n=61)</a:t>
            </a:r>
          </a:p>
          <a:p>
            <a:r>
              <a:rPr kumimoji="1" lang="ja-JP" altLang="en-US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/Foxp3 low (n=60)</a:t>
            </a:r>
          </a:p>
        </p:txBody>
      </p:sp>
      <p:pic>
        <p:nvPicPr>
          <p:cNvPr id="86" name="図 85">
            <a:extLst>
              <a:ext uri="{FF2B5EF4-FFF2-40B4-BE49-F238E27FC236}">
                <a16:creationId xmlns:a16="http://schemas.microsoft.com/office/drawing/2014/main" id="{C4E64988-C8AD-74AE-4B58-C0C17B9A8448}"/>
              </a:ext>
            </a:extLst>
          </p:cNvPr>
          <p:cNvPicPr>
            <a:picLocks noChangeAspect="1"/>
          </p:cNvPicPr>
          <p:nvPr/>
        </p:nvPicPr>
        <p:blipFill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2109" y="835154"/>
            <a:ext cx="2852024" cy="1776977"/>
          </a:xfrm>
          <a:prstGeom prst="rect">
            <a:avLst/>
          </a:prstGeom>
        </p:spPr>
      </p:pic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A4D892CC-0CFA-FCC5-AFA5-556E63BD1819}"/>
              </a:ext>
            </a:extLst>
          </p:cNvPr>
          <p:cNvSpPr txBox="1"/>
          <p:nvPr/>
        </p:nvSpPr>
        <p:spPr>
          <a:xfrm>
            <a:off x="744197" y="2324230"/>
            <a:ext cx="2076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months)</a:t>
            </a: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257D0175-83F9-A4D9-F6AA-538FE8C2DF56}"/>
              </a:ext>
            </a:extLst>
          </p:cNvPr>
          <p:cNvSpPr txBox="1"/>
          <p:nvPr/>
        </p:nvSpPr>
        <p:spPr>
          <a:xfrm rot="16200000">
            <a:off x="-759189" y="1467662"/>
            <a:ext cx="2120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ression-free survival rate</a:t>
            </a: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31406525-4AF1-0492-49F4-925982DE9A1C}"/>
              </a:ext>
            </a:extLst>
          </p:cNvPr>
          <p:cNvSpPr txBox="1"/>
          <p:nvPr/>
        </p:nvSpPr>
        <p:spPr>
          <a:xfrm>
            <a:off x="595997" y="1939168"/>
            <a:ext cx="8662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19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DE2CE692-3AA8-BC84-BF42-7EB0601C9AD2}"/>
              </a:ext>
            </a:extLst>
          </p:cNvPr>
          <p:cNvSpPr txBox="1"/>
          <p:nvPr/>
        </p:nvSpPr>
        <p:spPr>
          <a:xfrm>
            <a:off x="1434788" y="990308"/>
            <a:ext cx="15871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200" b="1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 high (n=61)</a:t>
            </a:r>
          </a:p>
          <a:p>
            <a:r>
              <a:rPr kumimoji="1" lang="ja-JP" altLang="en-US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3 low (n=60)</a:t>
            </a:r>
          </a:p>
        </p:txBody>
      </p:sp>
      <p:pic>
        <p:nvPicPr>
          <p:cNvPr id="91" name="図 90">
            <a:extLst>
              <a:ext uri="{FF2B5EF4-FFF2-40B4-BE49-F238E27FC236}">
                <a16:creationId xmlns:a16="http://schemas.microsoft.com/office/drawing/2014/main" id="{918DCF42-E10B-3DAB-ECF3-D02DB699D395}"/>
              </a:ext>
            </a:extLst>
          </p:cNvPr>
          <p:cNvPicPr>
            <a:picLocks noChangeAspect="1"/>
          </p:cNvPicPr>
          <p:nvPr/>
        </p:nvPicPr>
        <p:blipFill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92109" y="2845268"/>
            <a:ext cx="2852024" cy="1776977"/>
          </a:xfrm>
          <a:prstGeom prst="rect">
            <a:avLst/>
          </a:prstGeom>
        </p:spPr>
      </p:pic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1E8DE1EA-3066-E77A-7107-8308B706FAEF}"/>
              </a:ext>
            </a:extLst>
          </p:cNvPr>
          <p:cNvSpPr txBox="1"/>
          <p:nvPr/>
        </p:nvSpPr>
        <p:spPr>
          <a:xfrm>
            <a:off x="744197" y="4321383"/>
            <a:ext cx="2076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months)</a:t>
            </a: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B3771543-08AF-8E12-18EE-1C2C9E9E943D}"/>
              </a:ext>
            </a:extLst>
          </p:cNvPr>
          <p:cNvSpPr txBox="1"/>
          <p:nvPr/>
        </p:nvSpPr>
        <p:spPr>
          <a:xfrm>
            <a:off x="595997" y="3936321"/>
            <a:ext cx="8662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7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10F612F4-4B54-3809-C9E4-25F05AB9DCD4}"/>
              </a:ext>
            </a:extLst>
          </p:cNvPr>
          <p:cNvSpPr txBox="1"/>
          <p:nvPr/>
        </p:nvSpPr>
        <p:spPr>
          <a:xfrm>
            <a:off x="1434789" y="3003424"/>
            <a:ext cx="153279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ja-JP" altLang="en-US" sz="1200" b="1" dirty="0">
                <a:solidFill>
                  <a:schemeClr val="accent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 high (n=61)</a:t>
            </a:r>
          </a:p>
          <a:p>
            <a:r>
              <a:rPr kumimoji="1" lang="ja-JP" altLang="en-US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ー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8 low (n=60)</a:t>
            </a: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B0561CAE-D5E8-9CC8-72D7-2B1DB0831CAD}"/>
              </a:ext>
            </a:extLst>
          </p:cNvPr>
          <p:cNvSpPr txBox="1"/>
          <p:nvPr/>
        </p:nvSpPr>
        <p:spPr>
          <a:xfrm rot="16200000">
            <a:off x="-763321" y="3497479"/>
            <a:ext cx="21202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gression-free survival rate</a:t>
            </a:r>
          </a:p>
        </p:txBody>
      </p:sp>
    </p:spTree>
    <p:extLst>
      <p:ext uri="{BB962C8B-B14F-4D97-AF65-F5344CB8AC3E}">
        <p14:creationId xmlns:p14="http://schemas.microsoft.com/office/powerpoint/2010/main" val="6685377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91068</TotalTime>
  <Words>190</Words>
  <Application>Microsoft Office PowerPoint</Application>
  <PresentationFormat>A4 210 x 297 mm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omi1001</dc:creator>
  <cp:lastModifiedBy>慈人 中井</cp:lastModifiedBy>
  <cp:revision>3161</cp:revision>
  <dcterms:created xsi:type="dcterms:W3CDTF">2017-04-11T12:43:51Z</dcterms:created>
  <dcterms:modified xsi:type="dcterms:W3CDTF">2025-02-05T10:04:50Z</dcterms:modified>
</cp:coreProperties>
</file>